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DEA7F-12C1-4D12-8167-67B7517D52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86D37-0EEF-41AD-9515-5509EBF9B7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97507-268C-4CFD-BDB6-BC6BFD0FCB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7DB23-7B5C-4A6E-9FB9-C1DB71D192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917B7-A9E1-4F18-B001-7583B34720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1EAAE-6BD5-44B9-BB67-C3A8FE6C63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B301C8-432C-46BD-B59A-8DF51BF311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0542D-442C-4758-A040-87A7AAE276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6CEC38-99E6-4370-8C2F-1879DF9DE3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C6F4B-85D4-4FF4-BF1E-287F548978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79C8F-B6E5-4150-A231-A01AE98F00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91F0C5-0615-4384-BBAE-0D2905C40E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12/3/20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59DC86-AAE6-4ADC-AC18-67566300F84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Bivariate associations between markers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14200" y="1341360"/>
          <a:ext cx="8894880" cy="4175280"/>
        </p:xfrm>
        <a:graphic>
          <a:graphicData uri="http://schemas.openxmlformats.org/drawingml/2006/table">
            <a:tbl>
              <a:tblPr/>
              <a:tblGrid>
                <a:gridCol w="1673280"/>
                <a:gridCol w="722520"/>
                <a:gridCol w="720720"/>
                <a:gridCol w="722160"/>
                <a:gridCol w="722160"/>
                <a:gridCol w="722520"/>
                <a:gridCol w="722160"/>
                <a:gridCol w="722520"/>
                <a:gridCol w="722160"/>
                <a:gridCol w="722520"/>
                <a:gridCol w="722160"/>
              </a:tblGrid>
              <a:tr h="509760">
                <a:tc gridSpan="2"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IGFBP2 Hscore cut off at 50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IGF2R IRS cut off at 50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IGF1R-alpha IRS cut off at 50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1720">
                <a:tc gridSpan="2"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P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0640">
                <a:tc gridSpan="11">
                  <a:txBody>
                    <a:bodyPr lIns="39960" rIns="399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38120">
                <a:tc rowSpan="2">
                  <a:txBody>
                    <a:bodyPr lIns="39960" rIns="399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IGF2R IRS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cut off at 50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55 (39.1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91 (49.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0.0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38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241 (60.9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94 (50.4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5600">
                <a:tc gridSpan="11">
                  <a:txBody>
                    <a:bodyPr lIns="39960" rIns="399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38120">
                <a:tc rowSpan="2">
                  <a:txBody>
                    <a:bodyPr lIns="39960" rIns="399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IGF1R-alpha IRS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cut off at 50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06 (23.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61 (35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&lt;</a:t>
                      </a:r>
                      <a:r>
                        <a:rPr b="0" lang="el-GR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0.00</a:t>
                      </a: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17 (26.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19 (34.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0.0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36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349 (76.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289 (64.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322 (73.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229 (65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62080">
                <a:tc gridSpan="11">
                  <a:txBody>
                    <a:bodyPr lIns="39960" rIns="399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38120">
                <a:tc rowSpan="2">
                  <a:txBody>
                    <a:bodyPr lIns="39960" rIns="399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IGF1R-beta  IRS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cut off at 50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77 (23.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49 (42.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&lt;</a:t>
                      </a:r>
                      <a:r>
                        <a:rPr b="0" lang="el-GR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0.00</a:t>
                      </a: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89 (24.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06 (38.1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&lt;</a:t>
                      </a:r>
                      <a:r>
                        <a:rPr b="0" lang="el-GR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0.00</a:t>
                      </a: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30 (27.0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96 (47.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&lt;</a:t>
                      </a:r>
                      <a:r>
                        <a:rPr b="1" lang="el-GR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0.00</a:t>
                      </a:r>
                      <a:r>
                        <a:rPr b="1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SimHe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36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253 (76.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204 (57.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274 (75.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72 (61.9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351 (73.0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Calibri"/>
                          <a:ea typeface="SimHei"/>
                        </a:rPr>
                        <a:t>107 (52.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960" rIns="399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Bef>
                          <a:spcPts val="400"/>
                        </a:spcBef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9960" marR="39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3" name="Date Placeholder 4"/>
          <p:cNvSpPr/>
          <p:nvPr/>
        </p:nvSpPr>
        <p:spPr>
          <a:xfrm>
            <a:off x="45720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12/3/20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Slide Number Placeholder 5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3547F3-72B7-44FA-8142-1C1086D140B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03T17:24:17Z</dcterms:created>
  <dc:creator>Ζωή Αλεξοπούλου</dc:creator>
  <dc:description/>
  <dc:language>en-US</dc:language>
  <cp:lastModifiedBy>Γιώργος Κουβατσέας</cp:lastModifiedBy>
  <dcterms:modified xsi:type="dcterms:W3CDTF">2013-12-05T08:09:15Z</dcterms:modified>
  <cp:revision>21</cp:revision>
  <dc:subject/>
  <dc:title>Response to Reviewer </dc:title>
</cp:coreProperties>
</file>